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57" r:id="rId2"/>
    <p:sldId id="262" r:id="rId3"/>
    <p:sldId id="261" r:id="rId4"/>
    <p:sldId id="260" r:id="rId5"/>
    <p:sldId id="258" r:id="rId6"/>
    <p:sldId id="259" r:id="rId7"/>
    <p:sldId id="256" r:id="rId8"/>
  </p:sldIdLst>
  <p:sldSz cx="6121400" cy="6119813"/>
  <p:notesSz cx="9144000" cy="6858000"/>
  <p:defaultTextStyle>
    <a:defPPr>
      <a:defRPr lang="en-US"/>
    </a:defPPr>
    <a:lvl1pPr marL="0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1pPr>
    <a:lvl2pPr marL="349885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2pPr>
    <a:lvl3pPr marL="699135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3pPr>
    <a:lvl4pPr marL="1049020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4pPr>
    <a:lvl5pPr marL="1398905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5pPr>
    <a:lvl6pPr marL="1748790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6pPr>
    <a:lvl7pPr marL="2098040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7pPr>
    <a:lvl8pPr marL="2447925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8pPr>
    <a:lvl9pPr marL="2797810" algn="l" defTabSz="349885" rtl="0" eaLnBrk="1" latinLnBrk="0" hangingPunct="1">
      <a:defRPr sz="137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184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3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image" Target="../media/image46.emf"/><Relationship Id="rId1" Type="http://schemas.openxmlformats.org/officeDocument/2006/relationships/image" Target="../media/image45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9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900"/>
            </a:lvl1pPr>
          </a:lstStyle>
          <a:p>
            <a:fld id="{0F9B84EA-7D68-4D60-9CB1-D50884785D1C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9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9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106" y="1001554"/>
            <a:ext cx="5203190" cy="2130602"/>
          </a:xfrm>
        </p:spPr>
        <p:txBody>
          <a:bodyPr anchor="b"/>
          <a:lstStyle>
            <a:lvl1pPr algn="ctr">
              <a:defRPr sz="39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5176" y="3214320"/>
            <a:ext cx="4591050" cy="1477538"/>
          </a:xfrm>
        </p:spPr>
        <p:txBody>
          <a:bodyPr/>
          <a:lstStyle>
            <a:lvl1pPr marL="0" indent="0" algn="ctr">
              <a:buNone/>
              <a:defRPr sz="1590"/>
            </a:lvl1pPr>
            <a:lvl2pPr marL="302895" indent="0" algn="ctr">
              <a:buNone/>
              <a:defRPr sz="1325"/>
            </a:lvl2pPr>
            <a:lvl3pPr marL="605155" indent="0" algn="ctr">
              <a:buNone/>
              <a:defRPr sz="1190"/>
            </a:lvl3pPr>
            <a:lvl4pPr marL="908050" indent="0" algn="ctr">
              <a:buNone/>
              <a:defRPr sz="1060"/>
            </a:lvl4pPr>
            <a:lvl5pPr marL="1210310" indent="0" algn="ctr">
              <a:buNone/>
              <a:defRPr sz="1060"/>
            </a:lvl5pPr>
            <a:lvl6pPr marL="1513205" indent="0" algn="ctr">
              <a:buNone/>
              <a:defRPr sz="1060"/>
            </a:lvl6pPr>
            <a:lvl7pPr marL="1815465" indent="0" algn="ctr">
              <a:buNone/>
              <a:defRPr sz="1060"/>
            </a:lvl7pPr>
            <a:lvl8pPr marL="2118360" indent="0" algn="ctr">
              <a:buNone/>
              <a:defRPr sz="1060"/>
            </a:lvl8pPr>
            <a:lvl9pPr marL="2420620" indent="0" algn="ctr">
              <a:buNone/>
              <a:defRPr sz="10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80628" y="325824"/>
            <a:ext cx="1319926" cy="518625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846" y="325824"/>
            <a:ext cx="3883264" cy="518625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659" y="1525706"/>
            <a:ext cx="5279708" cy="2545672"/>
          </a:xfrm>
        </p:spPr>
        <p:txBody>
          <a:bodyPr anchor="b"/>
          <a:lstStyle>
            <a:lvl1pPr>
              <a:defRPr sz="39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659" y="4095461"/>
            <a:ext cx="5279708" cy="1338709"/>
          </a:xfrm>
        </p:spPr>
        <p:txBody>
          <a:bodyPr/>
          <a:lstStyle>
            <a:lvl1pPr marL="0" indent="0">
              <a:buNone/>
              <a:defRPr sz="1590">
                <a:solidFill>
                  <a:schemeClr val="tx1"/>
                </a:solidFill>
              </a:defRPr>
            </a:lvl1pPr>
            <a:lvl2pPr marL="30289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2pPr>
            <a:lvl3pPr marL="605155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3pPr>
            <a:lvl4pPr marL="908050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4pPr>
            <a:lvl5pPr marL="1210310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5pPr>
            <a:lvl6pPr marL="1513205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6pPr>
            <a:lvl7pPr marL="1815465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7pPr>
            <a:lvl8pPr marL="2118360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8pPr>
            <a:lvl9pPr marL="2420620" indent="0">
              <a:buNone/>
              <a:defRPr sz="10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847" y="1629118"/>
            <a:ext cx="2601595" cy="3882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960" y="1629118"/>
            <a:ext cx="2601595" cy="388296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645" y="325826"/>
            <a:ext cx="5279708" cy="118288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645" y="1500206"/>
            <a:ext cx="2589638" cy="735227"/>
          </a:xfrm>
        </p:spPr>
        <p:txBody>
          <a:bodyPr anchor="b"/>
          <a:lstStyle>
            <a:lvl1pPr marL="0" indent="0">
              <a:buNone/>
              <a:defRPr sz="1590" b="1"/>
            </a:lvl1pPr>
            <a:lvl2pPr marL="302895" indent="0">
              <a:buNone/>
              <a:defRPr sz="1325" b="1"/>
            </a:lvl2pPr>
            <a:lvl3pPr marL="605155" indent="0">
              <a:buNone/>
              <a:defRPr sz="1190" b="1"/>
            </a:lvl3pPr>
            <a:lvl4pPr marL="908050" indent="0">
              <a:buNone/>
              <a:defRPr sz="1060" b="1"/>
            </a:lvl4pPr>
            <a:lvl5pPr marL="1210310" indent="0">
              <a:buNone/>
              <a:defRPr sz="1060" b="1"/>
            </a:lvl5pPr>
            <a:lvl6pPr marL="1513205" indent="0">
              <a:buNone/>
              <a:defRPr sz="1060" b="1"/>
            </a:lvl6pPr>
            <a:lvl7pPr marL="1815465" indent="0">
              <a:buNone/>
              <a:defRPr sz="1060" b="1"/>
            </a:lvl7pPr>
            <a:lvl8pPr marL="2118360" indent="0">
              <a:buNone/>
              <a:defRPr sz="1060" b="1"/>
            </a:lvl8pPr>
            <a:lvl9pPr marL="2420620" indent="0">
              <a:buNone/>
              <a:defRPr sz="10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645" y="2235433"/>
            <a:ext cx="2589638" cy="32879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960" y="1500206"/>
            <a:ext cx="2602392" cy="735227"/>
          </a:xfrm>
        </p:spPr>
        <p:txBody>
          <a:bodyPr anchor="b"/>
          <a:lstStyle>
            <a:lvl1pPr marL="0" indent="0">
              <a:buNone/>
              <a:defRPr sz="1590" b="1"/>
            </a:lvl1pPr>
            <a:lvl2pPr marL="302895" indent="0">
              <a:buNone/>
              <a:defRPr sz="1325" b="1"/>
            </a:lvl2pPr>
            <a:lvl3pPr marL="605155" indent="0">
              <a:buNone/>
              <a:defRPr sz="1190" b="1"/>
            </a:lvl3pPr>
            <a:lvl4pPr marL="908050" indent="0">
              <a:buNone/>
              <a:defRPr sz="1060" b="1"/>
            </a:lvl4pPr>
            <a:lvl5pPr marL="1210310" indent="0">
              <a:buNone/>
              <a:defRPr sz="1060" b="1"/>
            </a:lvl5pPr>
            <a:lvl6pPr marL="1513205" indent="0">
              <a:buNone/>
              <a:defRPr sz="1060" b="1"/>
            </a:lvl6pPr>
            <a:lvl7pPr marL="1815465" indent="0">
              <a:buNone/>
              <a:defRPr sz="1060" b="1"/>
            </a:lvl7pPr>
            <a:lvl8pPr marL="2118360" indent="0">
              <a:buNone/>
              <a:defRPr sz="1060" b="1"/>
            </a:lvl8pPr>
            <a:lvl9pPr marL="2420620" indent="0">
              <a:buNone/>
              <a:defRPr sz="10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960" y="2235433"/>
            <a:ext cx="2602392" cy="32879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645" y="407989"/>
            <a:ext cx="1974311" cy="1427956"/>
          </a:xfrm>
        </p:spPr>
        <p:txBody>
          <a:bodyPr anchor="b"/>
          <a:lstStyle>
            <a:lvl1pPr>
              <a:defRPr sz="21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2393" y="881141"/>
            <a:ext cx="3098959" cy="4349034"/>
          </a:xfrm>
        </p:spPr>
        <p:txBody>
          <a:bodyPr/>
          <a:lstStyle>
            <a:lvl1pPr>
              <a:defRPr sz="2120"/>
            </a:lvl1pPr>
            <a:lvl2pPr>
              <a:defRPr sz="1855"/>
            </a:lvl2pPr>
            <a:lvl3pPr>
              <a:defRPr sz="1590"/>
            </a:lvl3pPr>
            <a:lvl4pPr>
              <a:defRPr sz="1325"/>
            </a:lvl4pPr>
            <a:lvl5pPr>
              <a:defRPr sz="1325"/>
            </a:lvl5pPr>
            <a:lvl6pPr>
              <a:defRPr sz="1325"/>
            </a:lvl6pPr>
            <a:lvl7pPr>
              <a:defRPr sz="1325"/>
            </a:lvl7pPr>
            <a:lvl8pPr>
              <a:defRPr sz="1325"/>
            </a:lvl8pPr>
            <a:lvl9pPr>
              <a:defRPr sz="13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645" y="1835945"/>
            <a:ext cx="1974311" cy="3401313"/>
          </a:xfrm>
        </p:spPr>
        <p:txBody>
          <a:bodyPr/>
          <a:lstStyle>
            <a:lvl1pPr marL="0" indent="0">
              <a:buNone/>
              <a:defRPr sz="1060"/>
            </a:lvl1pPr>
            <a:lvl2pPr marL="302895" indent="0">
              <a:buNone/>
              <a:defRPr sz="925"/>
            </a:lvl2pPr>
            <a:lvl3pPr marL="605155" indent="0">
              <a:buNone/>
              <a:defRPr sz="795"/>
            </a:lvl3pPr>
            <a:lvl4pPr marL="908050" indent="0">
              <a:buNone/>
              <a:defRPr sz="660"/>
            </a:lvl4pPr>
            <a:lvl5pPr marL="1210310" indent="0">
              <a:buNone/>
              <a:defRPr sz="660"/>
            </a:lvl5pPr>
            <a:lvl6pPr marL="1513205" indent="0">
              <a:buNone/>
              <a:defRPr sz="660"/>
            </a:lvl6pPr>
            <a:lvl7pPr marL="1815465" indent="0">
              <a:buNone/>
              <a:defRPr sz="660"/>
            </a:lvl7pPr>
            <a:lvl8pPr marL="2118360" indent="0">
              <a:buNone/>
              <a:defRPr sz="660"/>
            </a:lvl8pPr>
            <a:lvl9pPr marL="2420620" indent="0">
              <a:buNone/>
              <a:defRPr sz="66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645" y="407989"/>
            <a:ext cx="1974311" cy="1427956"/>
          </a:xfrm>
        </p:spPr>
        <p:txBody>
          <a:bodyPr anchor="b"/>
          <a:lstStyle>
            <a:lvl1pPr>
              <a:defRPr sz="21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2393" y="881141"/>
            <a:ext cx="3098959" cy="4349034"/>
          </a:xfrm>
        </p:spPr>
        <p:txBody>
          <a:bodyPr anchor="t"/>
          <a:lstStyle>
            <a:lvl1pPr marL="0" indent="0">
              <a:buNone/>
              <a:defRPr sz="2120"/>
            </a:lvl1pPr>
            <a:lvl2pPr marL="302895" indent="0">
              <a:buNone/>
              <a:defRPr sz="1855"/>
            </a:lvl2pPr>
            <a:lvl3pPr marL="605155" indent="0">
              <a:buNone/>
              <a:defRPr sz="1590"/>
            </a:lvl3pPr>
            <a:lvl4pPr marL="908050" indent="0">
              <a:buNone/>
              <a:defRPr sz="1325"/>
            </a:lvl4pPr>
            <a:lvl5pPr marL="1210310" indent="0">
              <a:buNone/>
              <a:defRPr sz="1325"/>
            </a:lvl5pPr>
            <a:lvl6pPr marL="1513205" indent="0">
              <a:buNone/>
              <a:defRPr sz="1325"/>
            </a:lvl6pPr>
            <a:lvl7pPr marL="1815465" indent="0">
              <a:buNone/>
              <a:defRPr sz="1325"/>
            </a:lvl7pPr>
            <a:lvl8pPr marL="2118360" indent="0">
              <a:buNone/>
              <a:defRPr sz="1325"/>
            </a:lvl8pPr>
            <a:lvl9pPr marL="2420620" indent="0">
              <a:buNone/>
              <a:defRPr sz="13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645" y="1835945"/>
            <a:ext cx="1974311" cy="3401313"/>
          </a:xfrm>
        </p:spPr>
        <p:txBody>
          <a:bodyPr/>
          <a:lstStyle>
            <a:lvl1pPr marL="0" indent="0">
              <a:buNone/>
              <a:defRPr sz="1060"/>
            </a:lvl1pPr>
            <a:lvl2pPr marL="302895" indent="0">
              <a:buNone/>
              <a:defRPr sz="925"/>
            </a:lvl2pPr>
            <a:lvl3pPr marL="605155" indent="0">
              <a:buNone/>
              <a:defRPr sz="795"/>
            </a:lvl3pPr>
            <a:lvl4pPr marL="908050" indent="0">
              <a:buNone/>
              <a:defRPr sz="660"/>
            </a:lvl4pPr>
            <a:lvl5pPr marL="1210310" indent="0">
              <a:buNone/>
              <a:defRPr sz="660"/>
            </a:lvl5pPr>
            <a:lvl6pPr marL="1513205" indent="0">
              <a:buNone/>
              <a:defRPr sz="660"/>
            </a:lvl6pPr>
            <a:lvl7pPr marL="1815465" indent="0">
              <a:buNone/>
              <a:defRPr sz="660"/>
            </a:lvl7pPr>
            <a:lvl8pPr marL="2118360" indent="0">
              <a:buNone/>
              <a:defRPr sz="660"/>
            </a:lvl8pPr>
            <a:lvl9pPr marL="2420620" indent="0">
              <a:buNone/>
              <a:defRPr sz="66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848" y="325826"/>
            <a:ext cx="5279708" cy="1182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848" y="1629118"/>
            <a:ext cx="5279708" cy="38829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847" y="5672163"/>
            <a:ext cx="1377315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D982E-E131-42FE-A49C-D5F84D43D875}" type="datetimeFigureOut">
              <a:rPr lang="zh-CN" altLang="en-US" smtClean="0"/>
              <a:t>2025/4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715" y="5672163"/>
            <a:ext cx="2065973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3239" y="5672163"/>
            <a:ext cx="1377315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35117-7700-4110-9488-F81A85332B8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05155" rtl="0" eaLnBrk="1" latinLnBrk="0" hangingPunct="1">
        <a:lnSpc>
          <a:spcPct val="90000"/>
        </a:lnSpc>
        <a:spcBef>
          <a:spcPct val="0"/>
        </a:spcBef>
        <a:buNone/>
        <a:defRPr sz="29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1130" indent="-151130" algn="l" defTabSz="605155" rtl="0" eaLnBrk="1" latinLnBrk="0" hangingPunct="1">
        <a:lnSpc>
          <a:spcPct val="90000"/>
        </a:lnSpc>
        <a:spcBef>
          <a:spcPts val="660"/>
        </a:spcBef>
        <a:buFont typeface="Arial" panose="020B0604020202020204" pitchFamily="34" charset="0"/>
        <a:buChar char="•"/>
        <a:defRPr sz="1855" kern="1200">
          <a:solidFill>
            <a:schemeClr val="tx1"/>
          </a:solidFill>
          <a:latin typeface="+mn-lt"/>
          <a:ea typeface="+mn-ea"/>
          <a:cs typeface="+mn-cs"/>
        </a:defRPr>
      </a:lvl1pPr>
      <a:lvl2pPr marL="454025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590" kern="1200">
          <a:solidFill>
            <a:schemeClr val="tx1"/>
          </a:solidFill>
          <a:latin typeface="+mn-lt"/>
          <a:ea typeface="+mn-ea"/>
          <a:cs typeface="+mn-cs"/>
        </a:defRPr>
      </a:lvl2pPr>
      <a:lvl3pPr marL="756285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325" kern="1200">
          <a:solidFill>
            <a:schemeClr val="tx1"/>
          </a:solidFill>
          <a:latin typeface="+mn-lt"/>
          <a:ea typeface="+mn-ea"/>
          <a:cs typeface="+mn-cs"/>
        </a:defRPr>
      </a:lvl3pPr>
      <a:lvl4pPr marL="1059180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190" kern="1200">
          <a:solidFill>
            <a:schemeClr val="tx1"/>
          </a:solidFill>
          <a:latin typeface="+mn-lt"/>
          <a:ea typeface="+mn-ea"/>
          <a:cs typeface="+mn-cs"/>
        </a:defRPr>
      </a:lvl4pPr>
      <a:lvl5pPr marL="1361440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190" kern="1200">
          <a:solidFill>
            <a:schemeClr val="tx1"/>
          </a:solidFill>
          <a:latin typeface="+mn-lt"/>
          <a:ea typeface="+mn-ea"/>
          <a:cs typeface="+mn-cs"/>
        </a:defRPr>
      </a:lvl5pPr>
      <a:lvl6pPr marL="1664335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190" kern="1200">
          <a:solidFill>
            <a:schemeClr val="tx1"/>
          </a:solidFill>
          <a:latin typeface="+mn-lt"/>
          <a:ea typeface="+mn-ea"/>
          <a:cs typeface="+mn-cs"/>
        </a:defRPr>
      </a:lvl6pPr>
      <a:lvl7pPr marL="1967230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190" kern="1200">
          <a:solidFill>
            <a:schemeClr val="tx1"/>
          </a:solidFill>
          <a:latin typeface="+mn-lt"/>
          <a:ea typeface="+mn-ea"/>
          <a:cs typeface="+mn-cs"/>
        </a:defRPr>
      </a:lvl7pPr>
      <a:lvl8pPr marL="2269490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190" kern="1200">
          <a:solidFill>
            <a:schemeClr val="tx1"/>
          </a:solidFill>
          <a:latin typeface="+mn-lt"/>
          <a:ea typeface="+mn-ea"/>
          <a:cs typeface="+mn-cs"/>
        </a:defRPr>
      </a:lvl8pPr>
      <a:lvl9pPr marL="2572385" indent="-151130" algn="l" defTabSz="605155" rtl="0" eaLnBrk="1" latinLnBrk="0" hangingPunct="1">
        <a:lnSpc>
          <a:spcPct val="90000"/>
        </a:lnSpc>
        <a:spcBef>
          <a:spcPts val="330"/>
        </a:spcBef>
        <a:buFont typeface="Arial" panose="020B0604020202020204" pitchFamily="34" charset="0"/>
        <a:buChar char="•"/>
        <a:defRPr sz="11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1pPr>
      <a:lvl2pPr marL="302895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2pPr>
      <a:lvl3pPr marL="605155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3pPr>
      <a:lvl4pPr marL="908050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4pPr>
      <a:lvl5pPr marL="1210310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5pPr>
      <a:lvl6pPr marL="1513205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6pPr>
      <a:lvl7pPr marL="1815465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7pPr>
      <a:lvl8pPr marL="2118360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8pPr>
      <a:lvl9pPr marL="2420620" algn="l" defTabSz="605155" rtl="0" eaLnBrk="1" latinLnBrk="0" hangingPunct="1">
        <a:defRPr sz="11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tags" Target="../tags/tag2.xml"/><Relationship Id="rId7" Type="http://schemas.openxmlformats.org/officeDocument/2006/relationships/oleObject" Target="../embeddings/oleObject2.bin"/><Relationship Id="rId2" Type="http://schemas.openxmlformats.org/officeDocument/2006/relationships/tags" Target="../tags/tag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12.emf"/><Relationship Id="rId4" Type="http://schemas.openxmlformats.org/officeDocument/2006/relationships/slideLayout" Target="../slideLayouts/slideLayout2.xml"/><Relationship Id="rId9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13" Type="http://schemas.openxmlformats.org/officeDocument/2006/relationships/image" Target="../media/image18.jpeg"/><Relationship Id="rId3" Type="http://schemas.openxmlformats.org/officeDocument/2006/relationships/tags" Target="../tags/tag4.xml"/><Relationship Id="rId7" Type="http://schemas.openxmlformats.org/officeDocument/2006/relationships/image" Target="../media/image14.jpeg"/><Relationship Id="rId12" Type="http://schemas.openxmlformats.org/officeDocument/2006/relationships/image" Target="../media/image17.png"/><Relationship Id="rId2" Type="http://schemas.openxmlformats.org/officeDocument/2006/relationships/tags" Target="../tags/tag3.xml"/><Relationship Id="rId1" Type="http://schemas.openxmlformats.org/officeDocument/2006/relationships/vmlDrawing" Target="../drawings/vmlDrawing2.vml"/><Relationship Id="rId6" Type="http://schemas.openxmlformats.org/officeDocument/2006/relationships/slideLayout" Target="../slideLayouts/slideLayout2.xml"/><Relationship Id="rId11" Type="http://schemas.openxmlformats.org/officeDocument/2006/relationships/image" Target="../media/image16.png"/><Relationship Id="rId5" Type="http://schemas.openxmlformats.org/officeDocument/2006/relationships/tags" Target="../tags/tag6.xml"/><Relationship Id="rId10" Type="http://schemas.openxmlformats.org/officeDocument/2006/relationships/image" Target="../media/image13.emf"/><Relationship Id="rId4" Type="http://schemas.openxmlformats.org/officeDocument/2006/relationships/tags" Target="../tags/tag5.xml"/><Relationship Id="rId9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tags" Target="../tags/tag18.xml"/><Relationship Id="rId18" Type="http://schemas.openxmlformats.org/officeDocument/2006/relationships/tags" Target="../tags/tag23.xml"/><Relationship Id="rId26" Type="http://schemas.openxmlformats.org/officeDocument/2006/relationships/image" Target="../media/image20.emf"/><Relationship Id="rId3" Type="http://schemas.openxmlformats.org/officeDocument/2006/relationships/tags" Target="../tags/tag8.xml"/><Relationship Id="rId21" Type="http://schemas.openxmlformats.org/officeDocument/2006/relationships/image" Target="../media/image23.png"/><Relationship Id="rId34" Type="http://schemas.openxmlformats.org/officeDocument/2006/relationships/image" Target="../media/image30.jpeg"/><Relationship Id="rId7" Type="http://schemas.openxmlformats.org/officeDocument/2006/relationships/tags" Target="../tags/tag12.xml"/><Relationship Id="rId12" Type="http://schemas.openxmlformats.org/officeDocument/2006/relationships/tags" Target="../tags/tag17.xml"/><Relationship Id="rId17" Type="http://schemas.openxmlformats.org/officeDocument/2006/relationships/tags" Target="../tags/tag22.xml"/><Relationship Id="rId25" Type="http://schemas.openxmlformats.org/officeDocument/2006/relationships/oleObject" Target="../embeddings/oleObject6.bin"/><Relationship Id="rId33" Type="http://schemas.openxmlformats.org/officeDocument/2006/relationships/image" Target="../media/image29.jpeg"/><Relationship Id="rId2" Type="http://schemas.openxmlformats.org/officeDocument/2006/relationships/tags" Target="../tags/tag7.xml"/><Relationship Id="rId16" Type="http://schemas.openxmlformats.org/officeDocument/2006/relationships/tags" Target="../tags/tag21.xml"/><Relationship Id="rId20" Type="http://schemas.openxmlformats.org/officeDocument/2006/relationships/image" Target="../media/image22.png"/><Relationship Id="rId29" Type="http://schemas.openxmlformats.org/officeDocument/2006/relationships/image" Target="../media/image21.emf"/><Relationship Id="rId1" Type="http://schemas.openxmlformats.org/officeDocument/2006/relationships/vmlDrawing" Target="../drawings/vmlDrawing3.vml"/><Relationship Id="rId6" Type="http://schemas.openxmlformats.org/officeDocument/2006/relationships/tags" Target="../tags/tag11.xml"/><Relationship Id="rId11" Type="http://schemas.openxmlformats.org/officeDocument/2006/relationships/tags" Target="../tags/tag16.xml"/><Relationship Id="rId24" Type="http://schemas.openxmlformats.org/officeDocument/2006/relationships/image" Target="../media/image24.png"/><Relationship Id="rId32" Type="http://schemas.openxmlformats.org/officeDocument/2006/relationships/image" Target="../media/image28.jpeg"/><Relationship Id="rId5" Type="http://schemas.openxmlformats.org/officeDocument/2006/relationships/tags" Target="../tags/tag10.xml"/><Relationship Id="rId15" Type="http://schemas.openxmlformats.org/officeDocument/2006/relationships/tags" Target="../tags/tag20.xml"/><Relationship Id="rId23" Type="http://schemas.openxmlformats.org/officeDocument/2006/relationships/image" Target="../media/image19.emf"/><Relationship Id="rId28" Type="http://schemas.openxmlformats.org/officeDocument/2006/relationships/oleObject" Target="../embeddings/oleObject7.bin"/><Relationship Id="rId36" Type="http://schemas.openxmlformats.org/officeDocument/2006/relationships/image" Target="../media/image32.jpeg"/><Relationship Id="rId10" Type="http://schemas.openxmlformats.org/officeDocument/2006/relationships/tags" Target="../tags/tag15.xml"/><Relationship Id="rId19" Type="http://schemas.openxmlformats.org/officeDocument/2006/relationships/slideLayout" Target="../slideLayouts/slideLayout2.xml"/><Relationship Id="rId31" Type="http://schemas.openxmlformats.org/officeDocument/2006/relationships/image" Target="../media/image27.jpeg"/><Relationship Id="rId4" Type="http://schemas.openxmlformats.org/officeDocument/2006/relationships/tags" Target="../tags/tag9.xml"/><Relationship Id="rId9" Type="http://schemas.openxmlformats.org/officeDocument/2006/relationships/tags" Target="../tags/tag14.xml"/><Relationship Id="rId14" Type="http://schemas.openxmlformats.org/officeDocument/2006/relationships/tags" Target="../tags/tag19.xml"/><Relationship Id="rId22" Type="http://schemas.openxmlformats.org/officeDocument/2006/relationships/oleObject" Target="../embeddings/oleObject5.bin"/><Relationship Id="rId27" Type="http://schemas.openxmlformats.org/officeDocument/2006/relationships/image" Target="../media/image25.png"/><Relationship Id="rId30" Type="http://schemas.openxmlformats.org/officeDocument/2006/relationships/image" Target="../media/image26.jpeg"/><Relationship Id="rId35" Type="http://schemas.openxmlformats.org/officeDocument/2006/relationships/image" Target="../media/image31.jpeg"/><Relationship Id="rId8" Type="http://schemas.openxmlformats.org/officeDocument/2006/relationships/tags" Target="../tags/tag13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tags" Target="../tags/tag25.xml"/><Relationship Id="rId7" Type="http://schemas.openxmlformats.org/officeDocument/2006/relationships/image" Target="../media/image33.emf"/><Relationship Id="rId2" Type="http://schemas.openxmlformats.org/officeDocument/2006/relationships/tags" Target="../tags/tag24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8.bin"/><Relationship Id="rId5" Type="http://schemas.openxmlformats.org/officeDocument/2006/relationships/slideLayout" Target="../slideLayouts/slideLayout2.xml"/><Relationship Id="rId4" Type="http://schemas.openxmlformats.org/officeDocument/2006/relationships/tags" Target="../tags/tag26.xml"/><Relationship Id="rId9" Type="http://schemas.openxmlformats.org/officeDocument/2006/relationships/image" Target="../media/image35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37.png"/><Relationship Id="rId7" Type="http://schemas.openxmlformats.org/officeDocument/2006/relationships/image" Target="../media/image41.jpe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10" Type="http://schemas.openxmlformats.org/officeDocument/2006/relationships/image" Target="../media/image44.png"/><Relationship Id="rId4" Type="http://schemas.openxmlformats.org/officeDocument/2006/relationships/image" Target="../media/image38.jpeg"/><Relationship Id="rId9" Type="http://schemas.openxmlformats.org/officeDocument/2006/relationships/image" Target="../media/image43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49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46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48.emf"/><Relationship Id="rId4" Type="http://schemas.openxmlformats.org/officeDocument/2006/relationships/image" Target="../media/image45.emf"/><Relationship Id="rId9" Type="http://schemas.openxmlformats.org/officeDocument/2006/relationships/oleObject" Target="../embeddings/oleObject1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765832" y="960022"/>
            <a:ext cx="3974851" cy="3392044"/>
            <a:chOff x="1104737" y="256335"/>
            <a:chExt cx="6005507" cy="5124957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8244" y="627927"/>
              <a:ext cx="1512000" cy="151200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92478" y="627927"/>
              <a:ext cx="1512000" cy="1512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96958" y="627927"/>
              <a:ext cx="1512000" cy="1512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8244" y="2254853"/>
              <a:ext cx="1512000" cy="1512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92478" y="2254853"/>
              <a:ext cx="1512000" cy="151200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96958" y="2254853"/>
              <a:ext cx="1512000" cy="15120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8244" y="3869292"/>
              <a:ext cx="1512000" cy="1512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92478" y="3869292"/>
              <a:ext cx="1512000" cy="1512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96958" y="3869292"/>
              <a:ext cx="1512000" cy="1512000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1357507" y="1181908"/>
              <a:ext cx="1011252" cy="36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6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96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4318172" y="256335"/>
              <a:ext cx="860612" cy="36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6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  <a:endParaRPr lang="zh-CN" altLang="en-US" sz="96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780431" y="256335"/>
              <a:ext cx="860612" cy="36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6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TF</a:t>
              </a:r>
              <a:endParaRPr lang="zh-CN" altLang="en-US" sz="96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5923939" y="256335"/>
              <a:ext cx="860612" cy="36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6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</a:t>
              </a:r>
              <a:endParaRPr lang="zh-CN" altLang="en-US" sz="96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104737" y="2793268"/>
              <a:ext cx="1264022" cy="36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6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igenin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230241" y="4453113"/>
              <a:ext cx="1138518" cy="3640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6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MSH</a:t>
              </a:r>
              <a:endParaRPr lang="zh-CN" altLang="en-US" sz="96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文本框 21"/>
          <p:cNvSpPr txBox="1"/>
          <p:nvPr/>
        </p:nvSpPr>
        <p:spPr>
          <a:xfrm>
            <a:off x="292100" y="4401820"/>
            <a:ext cx="5547995" cy="10604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0" algn="just" fontAlgn="auto">
              <a:lnSpc>
                <a:spcPct val="150000"/>
              </a:lnSpc>
            </a:pP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pigenin increases the expression of MITF in HEMCs.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mmunostaining by the immunofluorescence method was performed 12 h after treatment with apigenin or </a:t>
            </a:r>
            <a:r>
              <a:rPr lang="el-GR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α-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SH. MITF expression was detected by MITF Ab by immunofluorescent staining (green). Cells were counterstained with DAPI, which stain nuclei (blue). Bar=10 </a:t>
            </a:r>
            <a:r>
              <a:rPr lang="en-US" altLang="zh-CN" sz="105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05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262393" y="3748128"/>
            <a:ext cx="5604565" cy="10604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0" algn="just" fontAlgn="auto">
              <a:lnSpc>
                <a:spcPct val="150000"/>
              </a:lnSpc>
              <a:buClrTx/>
              <a:buSzTx/>
              <a:buFontTx/>
            </a:pP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0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Apigenin increases the mRNA level of Tyrosinase,TRP-1,TRP-2 in HEMCs.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MCs were treated with 10 μM apigenin for 0 h,4 h,12 h ,24 h and RT-qPCR was then applied to detect Tyrosinase,TRP-1 and TRP-2 gene expression. Data are expressed as the mean ± SEM (n = 3). *p &lt; 0.05, **p &lt; 0.01, ***p &lt; 0.001 versus non-treated cells.</a:t>
            </a:r>
          </a:p>
        </p:txBody>
      </p:sp>
      <p:graphicFrame>
        <p:nvGraphicFramePr>
          <p:cNvPr id="2" name="对象 1"/>
          <p:cNvGraphicFramePr/>
          <p:nvPr>
            <p:custDataLst>
              <p:tags r:id="rId2"/>
            </p:custDataLst>
          </p:nvPr>
        </p:nvGraphicFramePr>
        <p:xfrm>
          <a:off x="97705" y="1633763"/>
          <a:ext cx="2376000" cy="1905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7" name="Prism 8" r:id="rId5" imgW="3086100" imgH="2616200" progId="Prism8.Document">
                  <p:embed/>
                </p:oleObj>
              </mc:Choice>
              <mc:Fallback>
                <p:oleObj name="Prism 8" r:id="rId5" imgW="3086100" imgH="2616200" progId="Prism8.Document">
                  <p:embed/>
                  <p:pic>
                    <p:nvPicPr>
                      <p:cNvPr id="0" name="对象 4"/>
                      <p:cNvPicPr/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>
                      <a:xfrm>
                        <a:off x="97705" y="1633763"/>
                        <a:ext cx="2376000" cy="1905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/>
          <p:nvPr>
            <p:custDataLst>
              <p:tags r:id="rId3"/>
            </p:custDataLst>
          </p:nvPr>
        </p:nvGraphicFramePr>
        <p:xfrm>
          <a:off x="1995000" y="1643288"/>
          <a:ext cx="2377440" cy="1905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8" name="Prism 8" r:id="rId7" imgW="3111500" imgH="2597150" progId="Prism8.Document">
                  <p:embed/>
                </p:oleObj>
              </mc:Choice>
              <mc:Fallback>
                <p:oleObj name="Prism 8" r:id="rId7" imgW="3111500" imgH="2597150" progId="Prism8.Document">
                  <p:embed/>
                  <p:pic>
                    <p:nvPicPr>
                      <p:cNvPr id="0" name="对象 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95000" y="1643288"/>
                        <a:ext cx="2377440" cy="1905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/>
          <p:nvPr/>
        </p:nvGraphicFramePr>
        <p:xfrm>
          <a:off x="3929845" y="1643288"/>
          <a:ext cx="2377440" cy="1905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9" name="Prism 8" r:id="rId9" imgW="3111500" imgH="2597150" progId="Prism8.Document">
                  <p:embed/>
                </p:oleObj>
              </mc:Choice>
              <mc:Fallback>
                <p:oleObj name="Prism 8" r:id="rId9" imgW="3111500" imgH="2597150" progId="Prism8.Document">
                  <p:embed/>
                  <p:pic>
                    <p:nvPicPr>
                      <p:cNvPr id="0" name="对象 1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29845" y="1643288"/>
                        <a:ext cx="2377440" cy="1905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3"/>
          <p:cNvSpPr txBox="1"/>
          <p:nvPr>
            <p:custDataLst>
              <p:tags r:id="rId2"/>
            </p:custDataLst>
          </p:nvPr>
        </p:nvSpPr>
        <p:spPr>
          <a:xfrm>
            <a:off x="4843838" y="3695763"/>
            <a:ext cx="952663" cy="27989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6612" tIns="48304" rIns="96612" bIns="48304" numCol="1" spcCol="0" rtlCol="0" fromWordArt="0" anchor="t" anchorCtr="0" forceAA="0" compatLnSpc="1">
            <a:noAutofit/>
          </a:bodyPr>
          <a:lstStyle/>
          <a:p>
            <a:r>
              <a:rPr lang="en-US" altLang="zh-CN" sz="107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+              -           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509" y="2907656"/>
            <a:ext cx="1680000" cy="126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9977" y="2899705"/>
            <a:ext cx="1680000" cy="126000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049796" y="2605214"/>
            <a:ext cx="64081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NC </a:t>
            </a:r>
            <a:endParaRPr lang="zh-CN" altLang="en-US" sz="1200" dirty="0"/>
          </a:p>
        </p:txBody>
      </p:sp>
      <p:sp>
        <p:nvSpPr>
          <p:cNvPr id="11" name="文本框 10"/>
          <p:cNvSpPr txBox="1"/>
          <p:nvPr/>
        </p:nvSpPr>
        <p:spPr>
          <a:xfrm>
            <a:off x="2429125" y="2605214"/>
            <a:ext cx="15226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-Rab27a+si-Cdc42</a:t>
            </a:r>
            <a:endParaRPr lang="zh-CN" altLang="en-US" sz="1200" dirty="0"/>
          </a:p>
        </p:txBody>
      </p:sp>
      <p:sp>
        <p:nvSpPr>
          <p:cNvPr id="13" name="文本框 12"/>
          <p:cNvSpPr txBox="1"/>
          <p:nvPr/>
        </p:nvSpPr>
        <p:spPr>
          <a:xfrm>
            <a:off x="262393" y="4691103"/>
            <a:ext cx="5604565" cy="1383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Silencing Rab27a and Cdc42 abolishes apigenin-induced dendrite elongation and melanosome transport in HEMCs.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HEMCs were transfected with si-Rab27a and si-Cdc42 using transfection reagent. WB analysis was performed after 24 h. (B) HEMCs were transfected with si-NC, si-Rab27a and si-Cdc42 for 24 h, followed by apigenin (10 μM) treatment for 48 h. Dendritic morphology and pigment distribution were assessed by Masson-Fontana staining. The total dendrite length per cell was measured, and twenty cells per condition were analyzed in three independent experiments. Data are presented as mean ± SEM (n = 3). **p &lt; 0.01 vs. apigenin-only group (one-way ANOVA with Tukey’s test).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218918" y="2571593"/>
            <a:ext cx="261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B</a:t>
            </a:r>
            <a:endParaRPr lang="zh-CN" altLang="en-US" sz="1200" dirty="0"/>
          </a:p>
        </p:txBody>
      </p:sp>
      <p:sp>
        <p:nvSpPr>
          <p:cNvPr id="20" name="文本框 19"/>
          <p:cNvSpPr txBox="1"/>
          <p:nvPr/>
        </p:nvSpPr>
        <p:spPr>
          <a:xfrm rot="16200000">
            <a:off x="-6489" y="3517690"/>
            <a:ext cx="836616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igenin</a:t>
            </a:r>
          </a:p>
        </p:txBody>
      </p:sp>
      <p:graphicFrame>
        <p:nvGraphicFramePr>
          <p:cNvPr id="21" name="对象 22"/>
          <p:cNvGraphicFramePr>
            <a:graphicFrameLocks noChangeAspect="1"/>
          </p:cNvGraphicFramePr>
          <p:nvPr/>
        </p:nvGraphicFramePr>
        <p:xfrm>
          <a:off x="4184306" y="2172583"/>
          <a:ext cx="171132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8" r:id="rId9" imgW="3003550" imgH="2914650" progId="Prism8.Document">
                  <p:embed/>
                </p:oleObj>
              </mc:Choice>
              <mc:Fallback>
                <p:oleObj name="Prism 8" r:id="rId9" imgW="3003550" imgH="2914650" progId="Prism8.Document">
                  <p:embed/>
                  <p:pic>
                    <p:nvPicPr>
                      <p:cNvPr id="0" name="对象 2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84306" y="2172583"/>
                        <a:ext cx="1711325" cy="1600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文本框 23"/>
          <p:cNvSpPr txBox="1"/>
          <p:nvPr>
            <p:custDataLst>
              <p:tags r:id="rId3"/>
            </p:custDataLst>
          </p:nvPr>
        </p:nvSpPr>
        <p:spPr>
          <a:xfrm>
            <a:off x="4843838" y="4215677"/>
            <a:ext cx="881104" cy="21320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6612" tIns="48304" rIns="96612" bIns="48304" numCol="1" spcCol="0" rtlCol="0" fromWordArt="0" anchor="t" anchorCtr="0" forceAA="0" compatLnSpc="1">
            <a:noAutofit/>
          </a:bodyPr>
          <a:lstStyle/>
          <a:p>
            <a:r>
              <a:rPr lang="en-US" altLang="zh-CN" sz="107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+              + 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4065998" y="4240222"/>
            <a:ext cx="707491" cy="2300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8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Apigenin</a:t>
            </a:r>
            <a:endParaRPr lang="zh-CN" altLang="en-US" sz="895" dirty="0"/>
          </a:p>
        </p:txBody>
      </p:sp>
      <p:sp>
        <p:nvSpPr>
          <p:cNvPr id="25" name="文本框 24"/>
          <p:cNvSpPr txBox="1"/>
          <p:nvPr/>
        </p:nvSpPr>
        <p:spPr>
          <a:xfrm>
            <a:off x="4140516" y="3723807"/>
            <a:ext cx="632973" cy="2300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895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</a:t>
            </a:r>
            <a:r>
              <a:rPr lang="en-US" altLang="zh-CN" sz="895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NC </a:t>
            </a:r>
            <a:endParaRPr lang="zh-CN" altLang="en-US" sz="895" dirty="0"/>
          </a:p>
        </p:txBody>
      </p:sp>
      <p:sp>
        <p:nvSpPr>
          <p:cNvPr id="26" name="文本框 23"/>
          <p:cNvSpPr txBox="1"/>
          <p:nvPr>
            <p:custDataLst>
              <p:tags r:id="rId4"/>
            </p:custDataLst>
          </p:nvPr>
        </p:nvSpPr>
        <p:spPr>
          <a:xfrm>
            <a:off x="4843838" y="3881533"/>
            <a:ext cx="1277562" cy="213389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6612" tIns="48304" rIns="96612" bIns="48304" numCol="1" spcCol="0" rtlCol="0" fromWordArt="0" anchor="t" anchorCtr="0" forceAA="0" compatLnSpc="1">
            <a:noAutofit/>
          </a:bodyPr>
          <a:lstStyle/>
          <a:p>
            <a:r>
              <a:rPr lang="en-US" altLang="zh-CN" sz="107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  +                                  </a:t>
            </a:r>
          </a:p>
        </p:txBody>
      </p:sp>
      <p:sp>
        <p:nvSpPr>
          <p:cNvPr id="27" name="文本框 26"/>
          <p:cNvSpPr txBox="1"/>
          <p:nvPr/>
        </p:nvSpPr>
        <p:spPr>
          <a:xfrm>
            <a:off x="3951747" y="3908012"/>
            <a:ext cx="821742" cy="2300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895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-Rab27a </a:t>
            </a:r>
            <a:endParaRPr lang="zh-CN" altLang="en-US" sz="895" dirty="0"/>
          </a:p>
        </p:txBody>
      </p:sp>
      <p:sp>
        <p:nvSpPr>
          <p:cNvPr id="28" name="文本框 23"/>
          <p:cNvSpPr txBox="1"/>
          <p:nvPr>
            <p:custDataLst>
              <p:tags r:id="rId5"/>
            </p:custDataLst>
          </p:nvPr>
        </p:nvSpPr>
        <p:spPr>
          <a:xfrm>
            <a:off x="4843838" y="4049836"/>
            <a:ext cx="1207106" cy="22796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6612" tIns="48304" rIns="96612" bIns="48304" numCol="1" spcCol="0" rtlCol="0" fromWordArt="0" anchor="t" anchorCtr="0" forceAA="0" compatLnSpc="1">
            <a:noAutofit/>
          </a:bodyPr>
          <a:lstStyle/>
          <a:p>
            <a:r>
              <a:rPr lang="en-US" altLang="zh-CN" sz="107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  +    +                                  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3951747" y="4076315"/>
            <a:ext cx="821742" cy="2298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895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-Cdc42 </a:t>
            </a:r>
            <a:endParaRPr lang="zh-CN" altLang="en-US" sz="895" dirty="0"/>
          </a:p>
        </p:txBody>
      </p:sp>
      <p:pic>
        <p:nvPicPr>
          <p:cNvPr id="4" name="图片 3" descr="C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01445" y="1158240"/>
            <a:ext cx="1440000" cy="32888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" name="图片 1" descr="R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401445" y="748030"/>
            <a:ext cx="1440000" cy="3530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7" name="图片 46" descr="hacat HSP70-20h-30s-m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01445" y="1565275"/>
            <a:ext cx="1440000" cy="3318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文本框 8"/>
          <p:cNvSpPr txBox="1"/>
          <p:nvPr/>
        </p:nvSpPr>
        <p:spPr>
          <a:xfrm>
            <a:off x="644525" y="1570355"/>
            <a:ext cx="749935" cy="27178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644525" y="1148080"/>
            <a:ext cx="6718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42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644525" y="758190"/>
            <a:ext cx="9207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b27a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315720" y="358140"/>
            <a:ext cx="113919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NC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818005" y="358140"/>
            <a:ext cx="15995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Rab27a+si-Cdc42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262098" y="357983"/>
            <a:ext cx="261507" cy="275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A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17"/>
          <p:cNvSpPr>
            <a:spLocks noChangeAspect="1"/>
          </p:cNvSpPr>
          <p:nvPr>
            <p:custDataLst>
              <p:tags r:id="rId2"/>
            </p:custDataLst>
          </p:nvPr>
        </p:nvSpPr>
        <p:spPr>
          <a:xfrm>
            <a:off x="1000619" y="384669"/>
            <a:ext cx="539713" cy="155833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</a:p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      </a:t>
            </a:r>
            <a:endParaRPr lang="en-US" altLang="zh-CN" sz="795" b="1" kern="100" dirty="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" name="矩形 17"/>
          <p:cNvSpPr>
            <a:spLocks noChangeAspect="1"/>
          </p:cNvSpPr>
          <p:nvPr>
            <p:custDataLst>
              <p:tags r:id="rId3"/>
            </p:custDataLst>
          </p:nvPr>
        </p:nvSpPr>
        <p:spPr>
          <a:xfrm>
            <a:off x="1112361" y="608631"/>
            <a:ext cx="427971" cy="206764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</a:p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        </a:t>
            </a:r>
            <a:endParaRPr lang="en-US" altLang="zh-CN" sz="795" b="1" kern="100" dirty="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" name="矩形 17"/>
          <p:cNvSpPr>
            <a:spLocks noChangeAspect="1"/>
          </p:cNvSpPr>
          <p:nvPr>
            <p:custDataLst>
              <p:tags r:id="rId4"/>
            </p:custDataLst>
          </p:nvPr>
        </p:nvSpPr>
        <p:spPr>
          <a:xfrm>
            <a:off x="985540" y="839214"/>
            <a:ext cx="554793" cy="268034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RSK        </a:t>
            </a:r>
            <a:endParaRPr lang="en-US" altLang="zh-CN" sz="795" b="1" kern="100" dirty="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" name="矩形 17"/>
          <p:cNvSpPr>
            <a:spLocks noChangeAspect="1"/>
          </p:cNvSpPr>
          <p:nvPr>
            <p:custDataLst>
              <p:tags r:id="rId5"/>
            </p:custDataLst>
          </p:nvPr>
        </p:nvSpPr>
        <p:spPr>
          <a:xfrm>
            <a:off x="1112361" y="1055292"/>
            <a:ext cx="427971" cy="206764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RSK        </a:t>
            </a:r>
            <a:endParaRPr lang="en-US" altLang="zh-CN" sz="795" b="1" kern="100" dirty="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958754" y="1277452"/>
            <a:ext cx="581578" cy="16423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11" name="文本框 23"/>
          <p:cNvSpPr txBox="1"/>
          <p:nvPr>
            <p:custDataLst>
              <p:tags r:id="rId7"/>
            </p:custDataLst>
          </p:nvPr>
        </p:nvSpPr>
        <p:spPr>
          <a:xfrm>
            <a:off x="1654798" y="192033"/>
            <a:ext cx="1477050" cy="13089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3944" tIns="31971" rIns="63944" bIns="31971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+             -           + </a:t>
            </a:r>
          </a:p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 </a:t>
            </a:r>
          </a:p>
        </p:txBody>
      </p:sp>
      <p:sp>
        <p:nvSpPr>
          <p:cNvPr id="12" name="文本框 23"/>
          <p:cNvSpPr txBox="1"/>
          <p:nvPr>
            <p:custDataLst>
              <p:tags r:id="rId8"/>
            </p:custDataLst>
          </p:nvPr>
        </p:nvSpPr>
        <p:spPr>
          <a:xfrm>
            <a:off x="1654799" y="1"/>
            <a:ext cx="1406425" cy="22579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3944" tIns="31971" rIns="63944" bIns="31971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-             +           + </a:t>
            </a:r>
          </a:p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 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889331" y="0"/>
            <a:ext cx="675760" cy="214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Apigenin</a:t>
            </a:r>
            <a:endParaRPr lang="zh-CN" altLang="en-US" sz="795" dirty="0"/>
          </a:p>
        </p:txBody>
      </p:sp>
      <p:sp>
        <p:nvSpPr>
          <p:cNvPr id="14" name="文本框 13"/>
          <p:cNvSpPr txBox="1"/>
          <p:nvPr/>
        </p:nvSpPr>
        <p:spPr>
          <a:xfrm>
            <a:off x="889331" y="192031"/>
            <a:ext cx="675760" cy="214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ISCK03 </a:t>
            </a:r>
            <a:endParaRPr lang="zh-CN" altLang="en-US" sz="795" dirty="0"/>
          </a:p>
        </p:txBody>
      </p:sp>
      <p:pic>
        <p:nvPicPr>
          <p:cNvPr id="15" name="图片 14"/>
          <p:cNvPicPr preferRelativeResize="0"/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331" y="1333776"/>
            <a:ext cx="1429634" cy="15487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0" name="图片 19"/>
          <p:cNvPicPr preferRelativeResize="0"/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408575"/>
            <a:ext cx="1429634" cy="15487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22" name="对象 21"/>
          <p:cNvGraphicFramePr>
            <a:graphicFrameLocks noChangeAspect="1"/>
          </p:cNvGraphicFramePr>
          <p:nvPr/>
        </p:nvGraphicFramePr>
        <p:xfrm>
          <a:off x="3317148" y="98794"/>
          <a:ext cx="1767543" cy="13428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0" name="Prism 8" r:id="rId22" imgW="4946650" imgH="3917950" progId="Prism8.Document">
                  <p:embed/>
                </p:oleObj>
              </mc:Choice>
              <mc:Fallback>
                <p:oleObj name="Prism 8" r:id="rId22" imgW="4946650" imgH="3917950" progId="Prism8.Document">
                  <p:embed/>
                  <p:pic>
                    <p:nvPicPr>
                      <p:cNvPr id="0" name="对象 103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317148" y="98794"/>
                        <a:ext cx="1767543" cy="13428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矩形 17"/>
          <p:cNvSpPr>
            <a:spLocks noChangeAspect="1"/>
          </p:cNvSpPr>
          <p:nvPr>
            <p:custDataLst>
              <p:tags r:id="rId9"/>
            </p:custDataLst>
          </p:nvPr>
        </p:nvSpPr>
        <p:spPr>
          <a:xfrm>
            <a:off x="697070" y="2065017"/>
            <a:ext cx="834568" cy="263581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CREB         </a:t>
            </a:r>
            <a:endParaRPr lang="en-US" altLang="zh-CN" sz="795" b="1" kern="100" dirty="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4" name="矩形 17"/>
          <p:cNvSpPr>
            <a:spLocks noChangeAspect="1"/>
          </p:cNvSpPr>
          <p:nvPr>
            <p:custDataLst>
              <p:tags r:id="rId10"/>
            </p:custDataLst>
          </p:nvPr>
        </p:nvSpPr>
        <p:spPr>
          <a:xfrm>
            <a:off x="837742" y="2286281"/>
            <a:ext cx="693896" cy="219154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r"/>
            <a:r>
              <a:rPr lang="en-US" altLang="zh-CN" sz="795" b="1" dirty="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REB         </a:t>
            </a:r>
            <a:endParaRPr lang="en-US" altLang="zh-CN" sz="795" b="1" kern="100" dirty="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" name="文本框 24"/>
          <p:cNvSpPr txBox="1"/>
          <p:nvPr>
            <p:custDataLst>
              <p:tags r:id="rId11"/>
            </p:custDataLst>
          </p:nvPr>
        </p:nvSpPr>
        <p:spPr>
          <a:xfrm>
            <a:off x="822733" y="2488461"/>
            <a:ext cx="708904" cy="18437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795744" y="1678643"/>
            <a:ext cx="786406" cy="214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Apigenin</a:t>
            </a:r>
            <a:endParaRPr lang="zh-CN" altLang="en-US" sz="795" b="1" dirty="0"/>
          </a:p>
        </p:txBody>
      </p:sp>
      <p:sp>
        <p:nvSpPr>
          <p:cNvPr id="29" name="文本框 28"/>
          <p:cNvSpPr txBox="1"/>
          <p:nvPr/>
        </p:nvSpPr>
        <p:spPr>
          <a:xfrm>
            <a:off x="846709" y="1877348"/>
            <a:ext cx="735442" cy="214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I-D1870</a:t>
            </a:r>
            <a:endParaRPr lang="zh-CN" altLang="en-US" sz="795" b="1" dirty="0"/>
          </a:p>
        </p:txBody>
      </p:sp>
      <p:pic>
        <p:nvPicPr>
          <p:cNvPr id="31" name="图片 30"/>
          <p:cNvPicPr preferRelativeResize="0"/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331" y="1096880"/>
            <a:ext cx="1429634" cy="15487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33" name="对象 11"/>
          <p:cNvGraphicFramePr/>
          <p:nvPr/>
        </p:nvGraphicFramePr>
        <p:xfrm>
          <a:off x="3365689" y="1551381"/>
          <a:ext cx="1690406" cy="1255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1" name="Prism 8" r:id="rId25" imgW="3663950" imgH="2711450" progId="Prism8.Document">
                  <p:embed/>
                </p:oleObj>
              </mc:Choice>
              <mc:Fallback>
                <p:oleObj name="Prism 8" r:id="rId25" imgW="3663950" imgH="2711450" progId="Prism8.Document">
                  <p:embed/>
                  <p:pic>
                    <p:nvPicPr>
                      <p:cNvPr id="0" name="对象 11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2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65689" y="1551381"/>
                        <a:ext cx="1690406" cy="125585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文本框 23"/>
          <p:cNvSpPr txBox="1"/>
          <p:nvPr>
            <p:custDataLst>
              <p:tags r:id="rId12"/>
            </p:custDataLst>
          </p:nvPr>
        </p:nvSpPr>
        <p:spPr>
          <a:xfrm>
            <a:off x="1666355" y="1849337"/>
            <a:ext cx="1477050" cy="13089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3944" tIns="31971" rIns="63944" bIns="31971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+             -           + </a:t>
            </a:r>
          </a:p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 </a:t>
            </a:r>
          </a:p>
        </p:txBody>
      </p:sp>
      <p:sp>
        <p:nvSpPr>
          <p:cNvPr id="35" name="文本框 23"/>
          <p:cNvSpPr txBox="1"/>
          <p:nvPr>
            <p:custDataLst>
              <p:tags r:id="rId13"/>
            </p:custDataLst>
          </p:nvPr>
        </p:nvSpPr>
        <p:spPr>
          <a:xfrm>
            <a:off x="1666356" y="1657305"/>
            <a:ext cx="1406425" cy="22579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3944" tIns="31971" rIns="63944" bIns="31971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-             +           + </a:t>
            </a:r>
          </a:p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 </a:t>
            </a:r>
          </a:p>
        </p:txBody>
      </p:sp>
      <p:sp>
        <p:nvSpPr>
          <p:cNvPr id="36" name="文本框 35"/>
          <p:cNvSpPr txBox="1"/>
          <p:nvPr>
            <p:custDataLst>
              <p:tags r:id="rId14"/>
            </p:custDataLst>
          </p:nvPr>
        </p:nvSpPr>
        <p:spPr>
          <a:xfrm>
            <a:off x="845166" y="3280770"/>
            <a:ext cx="709363" cy="1911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osinase</a:t>
            </a:r>
          </a:p>
          <a:p>
            <a:pPr algn="r"/>
            <a:endParaRPr lang="en-US" altLang="zh-CN" sz="79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15"/>
            </p:custDataLst>
          </p:nvPr>
        </p:nvSpPr>
        <p:spPr>
          <a:xfrm>
            <a:off x="746493" y="3521020"/>
            <a:ext cx="808037" cy="1795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F</a:t>
            </a:r>
          </a:p>
        </p:txBody>
      </p:sp>
      <p:sp>
        <p:nvSpPr>
          <p:cNvPr id="38" name="文本框 37"/>
          <p:cNvSpPr txBox="1"/>
          <p:nvPr>
            <p:custDataLst>
              <p:tags r:id="rId16"/>
            </p:custDataLst>
          </p:nvPr>
        </p:nvSpPr>
        <p:spPr>
          <a:xfrm>
            <a:off x="854999" y="3744609"/>
            <a:ext cx="699530" cy="179593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pic>
        <p:nvPicPr>
          <p:cNvPr id="39" name="图片 38"/>
          <p:cNvPicPr preferRelativeResize="0"/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3773516"/>
            <a:ext cx="1429634" cy="15487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2" name="文本框 41"/>
          <p:cNvSpPr txBox="1"/>
          <p:nvPr/>
        </p:nvSpPr>
        <p:spPr>
          <a:xfrm>
            <a:off x="792477" y="2910215"/>
            <a:ext cx="786406" cy="214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Apigenin</a:t>
            </a:r>
            <a:endParaRPr lang="zh-CN" altLang="en-US" sz="795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843442" y="3108920"/>
            <a:ext cx="735442" cy="2145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795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I-D1870</a:t>
            </a:r>
            <a:endParaRPr lang="zh-CN" altLang="en-US" sz="795" b="1" dirty="0"/>
          </a:p>
        </p:txBody>
      </p:sp>
      <p:sp>
        <p:nvSpPr>
          <p:cNvPr id="44" name="文本框 23"/>
          <p:cNvSpPr txBox="1"/>
          <p:nvPr>
            <p:custDataLst>
              <p:tags r:id="rId17"/>
            </p:custDataLst>
          </p:nvPr>
        </p:nvSpPr>
        <p:spPr>
          <a:xfrm>
            <a:off x="1663088" y="3080910"/>
            <a:ext cx="1477050" cy="13089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3944" tIns="31971" rIns="63944" bIns="31971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+             -           + </a:t>
            </a:r>
          </a:p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 </a:t>
            </a:r>
          </a:p>
        </p:txBody>
      </p:sp>
      <p:sp>
        <p:nvSpPr>
          <p:cNvPr id="45" name="文本框 23"/>
          <p:cNvSpPr txBox="1"/>
          <p:nvPr>
            <p:custDataLst>
              <p:tags r:id="rId18"/>
            </p:custDataLst>
          </p:nvPr>
        </p:nvSpPr>
        <p:spPr>
          <a:xfrm>
            <a:off x="1663089" y="2888878"/>
            <a:ext cx="1406425" cy="22579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3944" tIns="31971" rIns="63944" bIns="31971" numCol="1" spcCol="0" rtlCol="0" fromWordArt="0" anchor="t" anchorCtr="0" forceAA="0" compatLnSpc="1">
            <a:noAutofit/>
          </a:bodyPr>
          <a:lstStyle/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-             -             +           + </a:t>
            </a:r>
          </a:p>
          <a:p>
            <a:pPr algn="just"/>
            <a:r>
              <a:rPr lang="en-US" altLang="zh-CN" sz="795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 </a:t>
            </a:r>
          </a:p>
        </p:txBody>
      </p:sp>
      <p:graphicFrame>
        <p:nvGraphicFramePr>
          <p:cNvPr id="46" name="对象 45"/>
          <p:cNvGraphicFramePr>
            <a:graphicFrameLocks noChangeAspect="1"/>
          </p:cNvGraphicFramePr>
          <p:nvPr/>
        </p:nvGraphicFramePr>
        <p:xfrm>
          <a:off x="3331383" y="2835042"/>
          <a:ext cx="1759017" cy="12945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2" name="Prism 8" r:id="rId28" imgW="4946650" imgH="3651250" progId="Prism8.Document">
                  <p:embed/>
                </p:oleObj>
              </mc:Choice>
              <mc:Fallback>
                <p:oleObj name="Prism 8" r:id="rId28" imgW="4946650" imgH="3651250" progId="Prism8.Document">
                  <p:embed/>
                  <p:pic>
                    <p:nvPicPr>
                      <p:cNvPr id="0" name="对象 21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331383" y="2835042"/>
                        <a:ext cx="1759017" cy="12945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图片 1"/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331" y="2078768"/>
            <a:ext cx="1429634" cy="1750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2304164"/>
            <a:ext cx="1429634" cy="18053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2541086"/>
            <a:ext cx="1429634" cy="1787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622053"/>
            <a:ext cx="1429634" cy="17992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3539117"/>
            <a:ext cx="1429634" cy="17988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331" y="868584"/>
            <a:ext cx="1429634" cy="17753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638" y="3300542"/>
            <a:ext cx="1429634" cy="1817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0" name="文本框 39"/>
          <p:cNvSpPr txBox="1"/>
          <p:nvPr/>
        </p:nvSpPr>
        <p:spPr>
          <a:xfrm>
            <a:off x="665928" y="18339"/>
            <a:ext cx="261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A</a:t>
            </a:r>
            <a:endParaRPr lang="zh-CN" altLang="en-US" sz="1200" dirty="0"/>
          </a:p>
        </p:txBody>
      </p:sp>
      <p:sp>
        <p:nvSpPr>
          <p:cNvPr id="41" name="文本框 40"/>
          <p:cNvSpPr txBox="1"/>
          <p:nvPr/>
        </p:nvSpPr>
        <p:spPr>
          <a:xfrm>
            <a:off x="640338" y="1625387"/>
            <a:ext cx="261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B</a:t>
            </a:r>
            <a:endParaRPr lang="zh-CN" altLang="en-US" sz="1200" dirty="0"/>
          </a:p>
        </p:txBody>
      </p:sp>
      <p:sp>
        <p:nvSpPr>
          <p:cNvPr id="47" name="文本框 46"/>
          <p:cNvSpPr txBox="1"/>
          <p:nvPr/>
        </p:nvSpPr>
        <p:spPr>
          <a:xfrm>
            <a:off x="670587" y="2897453"/>
            <a:ext cx="261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rPr>
              <a:t>C</a:t>
            </a:r>
            <a:endParaRPr lang="zh-CN" altLang="en-US" sz="1200" dirty="0"/>
          </a:p>
        </p:txBody>
      </p:sp>
      <p:sp>
        <p:nvSpPr>
          <p:cNvPr id="48" name="文本框 47"/>
          <p:cNvSpPr txBox="1"/>
          <p:nvPr/>
        </p:nvSpPr>
        <p:spPr>
          <a:xfrm>
            <a:off x="372557" y="4110264"/>
            <a:ext cx="5427607" cy="17068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sz="105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Apigenin promotes pigmentation through the c-KIT/MAPK/RSK signaling pathway.</a:t>
            </a:r>
            <a:r>
              <a:rPr lang="en-US" altLang="zh-CN" sz="1050" dirty="0">
                <a:solidFill>
                  <a:srgbClr val="000000"/>
                </a:solidFill>
                <a:latin typeface="Times New Roman" panose="02020603050405020304" pitchFamily="18" charset="0"/>
              </a:rPr>
              <a:t>(A) HEMCs were pretreated with or without 10 μM ISCK03 (inhibitor of c-KIT) for 1 h before apigenin was added for an additional 1 h. </a:t>
            </a:r>
            <a:r>
              <a:rPr lang="en-GB" altLang="zh-CN" sz="1050" dirty="0">
                <a:solidFill>
                  <a:srgbClr val="000000"/>
                </a:solidFill>
                <a:latin typeface="Times New Roman" panose="02020603050405020304" pitchFamily="18" charset="0"/>
              </a:rPr>
              <a:t>The p-ERK, ERK, p-RSK and RSK expression levels were measured using western blotting. </a:t>
            </a:r>
            <a:r>
              <a:rPr lang="en-US" altLang="zh-CN" sz="1050" dirty="0">
                <a:solidFill>
                  <a:srgbClr val="000000"/>
                </a:solidFill>
                <a:latin typeface="Times New Roman" panose="02020603050405020304" pitchFamily="18" charset="0"/>
              </a:rPr>
              <a:t>(B) HEMCs were pretreated with or without 10 μM BI-D1870 (inhibitor of RSK) for 1 h before apigenin was added for an additional 1 h. The p-CREB and CREB expression levels were measured using western blotting. </a:t>
            </a:r>
            <a:r>
              <a:rPr lang="en-GB" altLang="zh-CN" sz="1050" dirty="0">
                <a:solidFill>
                  <a:srgbClr val="000000"/>
                </a:solidFill>
                <a:latin typeface="Times New Roman" panose="02020603050405020304" pitchFamily="18" charset="0"/>
              </a:rPr>
              <a:t>(C) HEMCs were pretreated with or without 10 μM BI-D1870 (inhibitor of RSK) for 1 h before apigenin was added for 48 h. Tyrosinase and MITF expressions were measured as described previously. Data are expressed as means ± SEM (n = 3). *p &lt; 0.05, **p &lt; 0.01 vs. non-treated cells, </a:t>
            </a:r>
            <a:r>
              <a:rPr lang="en-GB" altLang="zh-CN" sz="10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#</a:t>
            </a:r>
            <a:r>
              <a:rPr lang="en-GB" altLang="zh-CN" sz="1050" dirty="0">
                <a:solidFill>
                  <a:srgbClr val="000000"/>
                </a:solidFill>
                <a:latin typeface="Times New Roman" panose="02020603050405020304" pitchFamily="18" charset="0"/>
              </a:rPr>
              <a:t>p &lt; 0.05, </a:t>
            </a:r>
            <a:r>
              <a:rPr lang="en-GB" altLang="zh-CN" sz="10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##</a:t>
            </a:r>
            <a:r>
              <a:rPr lang="en-GB" altLang="zh-CN" sz="1050" dirty="0">
                <a:solidFill>
                  <a:srgbClr val="000000"/>
                </a:solidFill>
                <a:latin typeface="Times New Roman" panose="02020603050405020304" pitchFamily="18" charset="0"/>
              </a:rPr>
              <a:t>p &lt; 0.01 vs. apigenin-treated cells.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>
            <p:custDataLst>
              <p:tags r:id="rId2"/>
            </p:custDataLst>
          </p:nvPr>
        </p:nvSpPr>
        <p:spPr>
          <a:xfrm>
            <a:off x="563559" y="2273859"/>
            <a:ext cx="751702" cy="23827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06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KIT</a:t>
            </a:r>
          </a:p>
          <a:p>
            <a:pPr algn="r"/>
            <a:endParaRPr lang="en-US" altLang="zh-CN" sz="106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zh-CN" sz="106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3"/>
            </p:custDataLst>
          </p:nvPr>
        </p:nvSpPr>
        <p:spPr>
          <a:xfrm>
            <a:off x="685960" y="2588289"/>
            <a:ext cx="629300" cy="17805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r>
              <a:rPr lang="en-US" altLang="zh-CN" sz="106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</a:p>
        </p:txBody>
      </p:sp>
      <p:graphicFrame>
        <p:nvGraphicFramePr>
          <p:cNvPr id="14" name="对象 13"/>
          <p:cNvGraphicFramePr/>
          <p:nvPr>
            <p:custDataLst>
              <p:tags r:id="rId4"/>
            </p:custDataLst>
          </p:nvPr>
        </p:nvGraphicFramePr>
        <p:xfrm>
          <a:off x="3676829" y="1509901"/>
          <a:ext cx="1708462" cy="17431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0" name="Prism 9" r:id="rId6" imgW="2622550" imgH="2819400" progId="Prism8.Document">
                  <p:embed/>
                </p:oleObj>
              </mc:Choice>
              <mc:Fallback>
                <p:oleObj name="Prism 9" r:id="rId6" imgW="2622550" imgH="2819400" progId="Prism8.Document">
                  <p:embed/>
                  <p:pic>
                    <p:nvPicPr>
                      <p:cNvPr id="0" name="对象 1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76829" y="1509901"/>
                        <a:ext cx="1708462" cy="17431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文本框 15"/>
          <p:cNvSpPr txBox="1"/>
          <p:nvPr/>
        </p:nvSpPr>
        <p:spPr>
          <a:xfrm>
            <a:off x="382340" y="3517704"/>
            <a:ext cx="5356722" cy="8185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0" fontAlgn="auto">
              <a:lnSpc>
                <a:spcPct val="150000"/>
              </a:lnSpc>
            </a:pPr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HEMCs were transfected with si-NC or si-c-KIT using transfection reagent.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 analysis was performed after 24 h. Data are expressed as the mean ± SD (n = 3). ***p &lt; 0.001 versus non-treated cells. 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2568" y="2273860"/>
            <a:ext cx="1906179" cy="26630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3" name="文本框 12"/>
          <p:cNvSpPr txBox="1"/>
          <p:nvPr/>
        </p:nvSpPr>
        <p:spPr>
          <a:xfrm>
            <a:off x="2325656" y="1802252"/>
            <a:ext cx="824662" cy="255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0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-c-KIT </a:t>
            </a:r>
            <a:endParaRPr lang="zh-CN" altLang="en-US" sz="1060" dirty="0"/>
          </a:p>
        </p:txBody>
      </p:sp>
      <p:sp>
        <p:nvSpPr>
          <p:cNvPr id="15" name="文本框 14"/>
          <p:cNvSpPr txBox="1"/>
          <p:nvPr/>
        </p:nvSpPr>
        <p:spPr>
          <a:xfrm>
            <a:off x="1534824" y="1824111"/>
            <a:ext cx="640814" cy="255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60" b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i</a:t>
            </a:r>
            <a:r>
              <a:rPr lang="en-US" altLang="zh-CN" sz="10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NC </a:t>
            </a:r>
            <a:endParaRPr lang="zh-CN" altLang="en-US" sz="106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2568" y="2629404"/>
            <a:ext cx="1906179" cy="2390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1855231" y="1193692"/>
            <a:ext cx="640814" cy="255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6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endParaRPr lang="zh-CN" altLang="en-US" sz="1060" dirty="0"/>
          </a:p>
        </p:txBody>
      </p:sp>
      <p:cxnSp>
        <p:nvCxnSpPr>
          <p:cNvPr id="5" name="直接连接符 4"/>
          <p:cNvCxnSpPr/>
          <p:nvPr/>
        </p:nvCxnSpPr>
        <p:spPr>
          <a:xfrm>
            <a:off x="1372567" y="2140339"/>
            <a:ext cx="90879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V="1">
            <a:off x="2334790" y="2135305"/>
            <a:ext cx="943957" cy="53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892332" y="1605556"/>
            <a:ext cx="669315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96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892701" y="960023"/>
            <a:ext cx="569610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96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719546" y="960023"/>
            <a:ext cx="892702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osinase</a:t>
            </a:r>
            <a:endParaRPr lang="zh-CN" altLang="en-US" sz="96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955505" y="960023"/>
            <a:ext cx="569610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zh-CN" altLang="en-US" sz="96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25031" y="2635094"/>
            <a:ext cx="836616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igenin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808099" y="3672858"/>
            <a:ext cx="753549" cy="240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6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MSH</a:t>
            </a:r>
            <a:endParaRPr lang="zh-CN" altLang="en-US" sz="96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4470714" y="4299231"/>
            <a:ext cx="238272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70644" y="4402067"/>
            <a:ext cx="5777872" cy="10604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0" algn="just" fontAlgn="auto">
              <a:lnSpc>
                <a:spcPct val="150000"/>
              </a:lnSpc>
            </a:pP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6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05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pigenin increases the expression of tyrosinase in human skin explants. 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mmunostaining by the immunofluorescence method was performed 5 d after treatment with apigenin </a:t>
            </a:r>
            <a:r>
              <a:rPr lang="el-GR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10 μ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) or </a:t>
            </a:r>
            <a:r>
              <a:rPr lang="el-GR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α-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SH (100 </a:t>
            </a:r>
            <a:r>
              <a:rPr lang="en-US" altLang="zh-CN" sz="105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altLang="zh-CN" sz="105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 Tyrosinase expression was detected by tyrosinase Ab by immunofluorescent staining (green). Cells were counterstained with DAPI, which stain nuclei (blue). </a:t>
            </a:r>
            <a:endParaRPr lang="zh-CN" altLang="zh-CN" sz="105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0976" y="3326577"/>
            <a:ext cx="1000744" cy="1000744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293" y="3326577"/>
            <a:ext cx="1000744" cy="1000744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6660" y="3326577"/>
            <a:ext cx="1000744" cy="1000744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0976" y="1224960"/>
            <a:ext cx="1000744" cy="1000744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293" y="1224960"/>
            <a:ext cx="1000744" cy="1000744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6660" y="1224960"/>
            <a:ext cx="1000744" cy="1000744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293" y="2273790"/>
            <a:ext cx="1000744" cy="1000744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6660" y="2273790"/>
            <a:ext cx="1000744" cy="1000744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0976" y="2273790"/>
            <a:ext cx="1000744" cy="1000744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28456" y="1184050"/>
            <a:ext cx="5264998" cy="2711407"/>
            <a:chOff x="746094" y="594812"/>
            <a:chExt cx="7954758" cy="4096600"/>
          </a:xfrm>
        </p:grpSpPr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746094" y="594812"/>
            <a:ext cx="276888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5" name="Prism 8" r:id="rId3" imgW="3949700" imgH="2825750" progId="Prism8.Document">
                    <p:embed/>
                  </p:oleObj>
                </mc:Choice>
                <mc:Fallback>
                  <p:oleObj name="Prism 8" r:id="rId3" imgW="3949700" imgH="2825750" progId="Prism8.Document">
                    <p:embed/>
                    <p:pic>
                      <p:nvPicPr>
                        <p:cNvPr id="0" name="对象 4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46094" y="594812"/>
                          <a:ext cx="276888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5"/>
            <p:cNvGraphicFramePr>
              <a:graphicFrameLocks noChangeAspect="1"/>
            </p:cNvGraphicFramePr>
            <p:nvPr/>
          </p:nvGraphicFramePr>
          <p:xfrm>
            <a:off x="3349375" y="594812"/>
            <a:ext cx="276888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6" name="Prism 8" r:id="rId5" imgW="3949700" imgH="2825750" progId="Prism8.Document">
                    <p:embed/>
                  </p:oleObj>
                </mc:Choice>
                <mc:Fallback>
                  <p:oleObj name="Prism 8" r:id="rId5" imgW="3949700" imgH="2825750" progId="Prism8.Document">
                    <p:embed/>
                    <p:pic>
                      <p:nvPicPr>
                        <p:cNvPr id="0" name="对象 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349375" y="594812"/>
                          <a:ext cx="276888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6"/>
            <p:cNvGraphicFramePr>
              <a:graphicFrameLocks noChangeAspect="1"/>
            </p:cNvGraphicFramePr>
            <p:nvPr/>
          </p:nvGraphicFramePr>
          <p:xfrm>
            <a:off x="746094" y="2711412"/>
            <a:ext cx="276888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7" name="Prism 8" r:id="rId7" imgW="3949700" imgH="2825750" progId="Prism8.Document">
                    <p:embed/>
                  </p:oleObj>
                </mc:Choice>
                <mc:Fallback>
                  <p:oleObj name="Prism 8" r:id="rId7" imgW="3949700" imgH="2825750" progId="Prism8.Document">
                    <p:embed/>
                    <p:pic>
                      <p:nvPicPr>
                        <p:cNvPr id="0" name="对象 6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46094" y="2711412"/>
                          <a:ext cx="276888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对象 7"/>
            <p:cNvGraphicFramePr>
              <a:graphicFrameLocks noChangeAspect="1"/>
            </p:cNvGraphicFramePr>
            <p:nvPr/>
          </p:nvGraphicFramePr>
          <p:xfrm>
            <a:off x="3349375" y="2711412"/>
            <a:ext cx="276888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8" name="Prism 8" r:id="rId9" imgW="3949700" imgH="2825750" progId="Prism8.Document">
                    <p:embed/>
                  </p:oleObj>
                </mc:Choice>
                <mc:Fallback>
                  <p:oleObj name="Prism 8" r:id="rId9" imgW="3949700" imgH="2825750" progId="Prism8.Document">
                    <p:embed/>
                    <p:pic>
                      <p:nvPicPr>
                        <p:cNvPr id="0" name="对象 7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349375" y="2711412"/>
                          <a:ext cx="276888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对象 8"/>
            <p:cNvGraphicFramePr>
              <a:graphicFrameLocks noChangeAspect="1"/>
            </p:cNvGraphicFramePr>
            <p:nvPr/>
          </p:nvGraphicFramePr>
          <p:xfrm>
            <a:off x="5931972" y="594812"/>
            <a:ext cx="2768880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9" name="Prism 8" r:id="rId11" imgW="3949700" imgH="2825750" progId="Prism8.Document">
                    <p:embed/>
                  </p:oleObj>
                </mc:Choice>
                <mc:Fallback>
                  <p:oleObj name="Prism 8" r:id="rId11" imgW="3949700" imgH="2825750" progId="Prism8.Document">
                    <p:embed/>
                    <p:pic>
                      <p:nvPicPr>
                        <p:cNvPr id="0" name="对象 8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931972" y="594812"/>
                          <a:ext cx="2768880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" name="文本框 9"/>
          <p:cNvSpPr txBox="1"/>
          <p:nvPr/>
        </p:nvSpPr>
        <p:spPr>
          <a:xfrm>
            <a:off x="150244" y="4108076"/>
            <a:ext cx="5759712" cy="13049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zh-CN" sz="105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US" altLang="zh-CN" sz="105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ctivation levels of different pathway components in correlation with melanin content in human samples.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tter plots demonstrate whether melanin contents correlate with tyrosinase enzymatic activity and/or with the levels of tyrosinase, MITF, Cdc42, and Rab27a expression in human samples.</a:t>
            </a:r>
            <a:endParaRPr lang="zh-CN" altLang="zh-CN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zh-CN" altLang="en-US" sz="10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501.872440944882,&quot;left&quot;:16.604330708661415,&quot;top&quot;:12.987559055118108,&quot;width&quot;:690.1707086614174}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501.872440944882,&quot;left&quot;:16.604330708661415,&quot;top&quot;:12.987559055118108,&quot;width&quot;:690.1707086614174}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DIAGRAM_VIRTUALLY_FRAME" val="{&quot;height&quot;:164.9,&quot;left&quot;:4.495433070866139,&quot;top&quot;:5.919448818897638,&quot;width&quot;:300.40456692913386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701</Words>
  <Application>Microsoft Office PowerPoint</Application>
  <PresentationFormat>自定义</PresentationFormat>
  <Paragraphs>76</Paragraphs>
  <Slides>7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主题​​</vt:lpstr>
      <vt:lpstr>Prism 8</vt:lpstr>
      <vt:lpstr>Prism 9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vjinpeng1988@126.com</dc:creator>
  <cp:lastModifiedBy>a34389</cp:lastModifiedBy>
  <cp:revision>41</cp:revision>
  <dcterms:created xsi:type="dcterms:W3CDTF">2024-08-10T06:53:00Z</dcterms:created>
  <dcterms:modified xsi:type="dcterms:W3CDTF">2025-04-14T02:24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AE60CF2BFA04ACF9C2841A86CCE06AF_13</vt:lpwstr>
  </property>
  <property fmtid="{D5CDD505-2E9C-101B-9397-08002B2CF9AE}" pid="3" name="KSOProductBuildVer">
    <vt:lpwstr>2052-12.1.0.20305</vt:lpwstr>
  </property>
</Properties>
</file>